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789CB0-7DDA-4562-93C4-68C3170488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7E935-2937-4902-98F3-0482EC7D83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BF993-D4C7-40CA-8AE6-42877C2BAF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8F6097-8E5F-4347-B5BD-9D0E65C455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BDF82-35CF-4EAA-ADA8-C10B766E40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32DA6-ECC5-481B-A341-F13B0FD610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25AE86-9B8F-43B1-A98D-0CDCEF52CF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A2CC4-EEAD-4EA7-A473-9D2CE025E6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487DB1-A44D-401B-BA44-D5645F101D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1F94D-FDBC-4292-905B-18E7586587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25181-AE02-4F5A-89FD-B56A570804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D3CED-D8F7-4900-8BB6-A776895D77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FBBD82-A376-489E-AC95-759481630708}" type="slidenum">
              <a:rPr b="0" lang="it-IT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80880" y="1295280"/>
            <a:ext cx="80884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</a:rPr>
              <a:t>Supplementary Figure S3: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chematic representation of Tn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1806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S. pneumonia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P200, in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omparison with the predicted genetic element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F. magn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ATCC29328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haded areas between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elements indicate areas of homology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56120" y="2608920"/>
            <a:ext cx="6081120" cy="3702600"/>
            <a:chOff x="456120" y="2608920"/>
            <a:chExt cx="6081120" cy="3702600"/>
          </a:xfrm>
        </p:grpSpPr>
        <p:sp>
          <p:nvSpPr>
            <p:cNvPr id="43" name=""/>
            <p:cNvSpPr/>
            <p:nvPr/>
          </p:nvSpPr>
          <p:spPr>
            <a:xfrm flipH="1" flipV="1">
              <a:off x="3593520" y="3928320"/>
              <a:ext cx="533160" cy="1366920"/>
            </a:xfrm>
            <a:prstGeom prst="parallelogram">
              <a:avLst>
                <a:gd name="adj" fmla="val 54347"/>
              </a:avLst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 flipH="1" flipV="1">
              <a:off x="4755600" y="3921840"/>
              <a:ext cx="438120" cy="1366920"/>
            </a:xfrm>
            <a:prstGeom prst="parallelogram">
              <a:avLst>
                <a:gd name="adj" fmla="val 50000"/>
              </a:avLst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963880" y="3911760"/>
              <a:ext cx="652320" cy="13316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 flipV="1">
              <a:off x="598320" y="3857040"/>
              <a:ext cx="295560" cy="13906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 rot="300000">
              <a:off x="1123200" y="3909600"/>
              <a:ext cx="101520" cy="1349280"/>
            </a:xfrm>
            <a:prstGeom prst="parallelogram">
              <a:avLst>
                <a:gd name="adj" fmla="val 34662"/>
              </a:avLst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48" name=""/>
            <p:cNvGrpSpPr/>
            <p:nvPr/>
          </p:nvGrpSpPr>
          <p:grpSpPr>
            <a:xfrm>
              <a:off x="1321920" y="3898800"/>
              <a:ext cx="1223640" cy="1373040"/>
              <a:chOff x="1321920" y="3898800"/>
              <a:chExt cx="1223640" cy="1373040"/>
            </a:xfrm>
          </p:grpSpPr>
          <p:sp>
            <p:nvSpPr>
              <p:cNvPr id="49" name=""/>
              <p:cNvSpPr/>
              <p:nvPr/>
            </p:nvSpPr>
            <p:spPr>
              <a:xfrm>
                <a:off x="1428120" y="3898800"/>
                <a:ext cx="1078200" cy="67320"/>
              </a:xfrm>
              <a:prstGeom prst="rect">
                <a:avLst/>
              </a:prstGeom>
              <a:solidFill>
                <a:srgbClr val="c0c0c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0520" bIns="20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50" name=""/>
              <p:cNvGrpSpPr/>
              <p:nvPr/>
            </p:nvGrpSpPr>
            <p:grpSpPr>
              <a:xfrm>
                <a:off x="1321920" y="3957840"/>
                <a:ext cx="1223640" cy="1314000"/>
                <a:chOff x="1321920" y="3957840"/>
                <a:chExt cx="1223640" cy="1314000"/>
              </a:xfrm>
            </p:grpSpPr>
            <p:sp>
              <p:nvSpPr>
                <p:cNvPr id="51" name=""/>
                <p:cNvSpPr/>
                <p:nvPr/>
              </p:nvSpPr>
              <p:spPr>
                <a:xfrm flipV="1" rot="287400">
                  <a:off x="1740960" y="3959280"/>
                  <a:ext cx="95400" cy="1307160"/>
                </a:xfrm>
                <a:prstGeom prst="parallelogram">
                  <a:avLst>
                    <a:gd name="adj" fmla="val 34662"/>
                  </a:avLst>
                </a:prstGeom>
                <a:solidFill>
                  <a:srgbClr val="c0c0c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grpSp>
              <p:nvGrpSpPr>
                <p:cNvPr id="52" name=""/>
                <p:cNvGrpSpPr/>
                <p:nvPr/>
              </p:nvGrpSpPr>
              <p:grpSpPr>
                <a:xfrm>
                  <a:off x="1321920" y="3957840"/>
                  <a:ext cx="1223640" cy="1314000"/>
                  <a:chOff x="1321920" y="3957840"/>
                  <a:chExt cx="1223640" cy="1314000"/>
                </a:xfrm>
              </p:grpSpPr>
              <p:sp>
                <p:nvSpPr>
                  <p:cNvPr id="53" name=""/>
                  <p:cNvSpPr/>
                  <p:nvPr/>
                </p:nvSpPr>
                <p:spPr>
                  <a:xfrm flipV="1" rot="287400">
                    <a:off x="1449000" y="3959280"/>
                    <a:ext cx="95400" cy="1307160"/>
                  </a:xfrm>
                  <a:prstGeom prst="parallelogram">
                    <a:avLst>
                      <a:gd name="adj" fmla="val 34662"/>
                    </a:avLst>
                  </a:prstGeom>
                  <a:solidFill>
                    <a:srgbClr val="c0c0c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Times New Roman"/>
                    </a:endParaRPr>
                  </a:p>
                </p:txBody>
              </p:sp>
              <p:grpSp>
                <p:nvGrpSpPr>
                  <p:cNvPr id="54" name=""/>
                  <p:cNvGrpSpPr/>
                  <p:nvPr/>
                </p:nvGrpSpPr>
                <p:grpSpPr>
                  <a:xfrm>
                    <a:off x="1321920" y="3957840"/>
                    <a:ext cx="1223640" cy="1314000"/>
                    <a:chOff x="1321920" y="3957840"/>
                    <a:chExt cx="1223640" cy="1314000"/>
                  </a:xfrm>
                </p:grpSpPr>
                <p:sp>
                  <p:nvSpPr>
                    <p:cNvPr id="55" name=""/>
                    <p:cNvSpPr/>
                    <p:nvPr/>
                  </p:nvSpPr>
                  <p:spPr>
                    <a:xfrm flipV="1" rot="287400">
                      <a:off x="1667880" y="3959280"/>
                      <a:ext cx="95040" cy="1307160"/>
                    </a:xfrm>
                    <a:prstGeom prst="parallelogram">
                      <a:avLst>
                        <a:gd name="adj" fmla="val 34662"/>
                      </a:avLst>
                    </a:prstGeom>
                    <a:solidFill>
                      <a:srgbClr val="c0c0c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ctr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p:txBody>
                </p:sp>
                <p:grpSp>
                  <p:nvGrpSpPr>
                    <p:cNvPr id="56" name=""/>
                    <p:cNvGrpSpPr/>
                    <p:nvPr/>
                  </p:nvGrpSpPr>
                  <p:grpSpPr>
                    <a:xfrm>
                      <a:off x="1321920" y="3957840"/>
                      <a:ext cx="1223640" cy="1314000"/>
                      <a:chOff x="1321920" y="3957840"/>
                      <a:chExt cx="1223640" cy="1314000"/>
                    </a:xfrm>
                  </p:grpSpPr>
                  <p:sp>
                    <p:nvSpPr>
                      <p:cNvPr id="57" name=""/>
                      <p:cNvSpPr/>
                      <p:nvPr/>
                    </p:nvSpPr>
                    <p:spPr>
                      <a:xfrm flipV="1" rot="287400">
                        <a:off x="1544400" y="3959280"/>
                        <a:ext cx="95040" cy="1307160"/>
                      </a:xfrm>
                      <a:prstGeom prst="parallelogram">
                        <a:avLst>
                          <a:gd name="adj" fmla="val 34662"/>
                        </a:avLst>
                      </a:prstGeom>
                      <a:solidFill>
                        <a:srgbClr val="c0c0c0"/>
                      </a:solidFill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46800" bIns="46800" anchor="ctr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Times New Roman"/>
                        </a:endParaRPr>
                      </a:p>
                    </p:txBody>
                  </p:sp>
                  <p:grpSp>
                    <p:nvGrpSpPr>
                      <p:cNvPr id="58" name=""/>
                      <p:cNvGrpSpPr/>
                      <p:nvPr/>
                    </p:nvGrpSpPr>
                    <p:grpSpPr>
                      <a:xfrm>
                        <a:off x="1321920" y="3957840"/>
                        <a:ext cx="1223640" cy="1314000"/>
                        <a:chOff x="1321920" y="3957840"/>
                        <a:chExt cx="1223640" cy="1314000"/>
                      </a:xfrm>
                    </p:grpSpPr>
                    <p:sp>
                      <p:nvSpPr>
                        <p:cNvPr id="59" name=""/>
                        <p:cNvSpPr/>
                        <p:nvPr/>
                      </p:nvSpPr>
                      <p:spPr>
                        <a:xfrm flipV="1" rot="287400">
                          <a:off x="2346120" y="3959280"/>
                          <a:ext cx="95400" cy="1307160"/>
                        </a:xfrm>
                        <a:prstGeom prst="parallelogram">
                          <a:avLst>
                            <a:gd name="adj" fmla="val 34662"/>
                          </a:avLst>
                        </a:prstGeom>
                        <a:solidFill>
                          <a:srgbClr val="c0c0c0"/>
                        </a:solidFill>
                        <a:ln w="0">
                          <a:noFill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wrap="none" lIns="90000" rIns="90000" tIns="46800" bIns="46800" anchor="ctr">
                          <a:noAutofit/>
                        </a:bodyPr>
                        <a:p>
                          <a:endParaRPr b="0" lang="en-US" sz="2400" spc="-1" strike="noStrike">
                            <a:solidFill>
                              <a:srgbClr val="000000"/>
                            </a:solidFill>
                            <a:latin typeface="Times New Roman"/>
                          </a:endParaRPr>
                        </a:p>
                      </p:txBody>
                    </p:sp>
                    <p:grpSp>
                      <p:nvGrpSpPr>
                        <p:cNvPr id="60" name=""/>
                        <p:cNvGrpSpPr/>
                        <p:nvPr/>
                      </p:nvGrpSpPr>
                      <p:grpSpPr>
                        <a:xfrm>
                          <a:off x="1321920" y="3957840"/>
                          <a:ext cx="1223640" cy="1314000"/>
                          <a:chOff x="1321920" y="3957840"/>
                          <a:chExt cx="1223640" cy="1314000"/>
                        </a:xfrm>
                      </p:grpSpPr>
                      <p:sp>
                        <p:nvSpPr>
                          <p:cNvPr id="61" name=""/>
                          <p:cNvSpPr/>
                          <p:nvPr/>
                        </p:nvSpPr>
                        <p:spPr>
                          <a:xfrm flipV="1" rot="287400">
                            <a:off x="1471320" y="3959280"/>
                            <a:ext cx="95400" cy="1307160"/>
                          </a:xfrm>
                          <a:prstGeom prst="parallelogram">
                            <a:avLst>
                              <a:gd name="adj" fmla="val 34662"/>
                            </a:avLst>
                          </a:prstGeom>
                          <a:solidFill>
                            <a:srgbClr val="c0c0c0"/>
                          </a:solidFill>
                          <a:ln w="0">
                            <a:noFill/>
                          </a:ln>
                        </p:spPr>
                        <p:style>
                          <a:lnRef idx="0"/>
                          <a:fillRef idx="0"/>
                          <a:effectRef idx="0"/>
                          <a:fontRef idx="minor"/>
                        </p:style>
                        <p:txBody>
                          <a:bodyPr wrap="none" lIns="90000" rIns="90000" tIns="46800" bIns="46800" anchor="ctr">
                            <a:noAutofit/>
                          </a:bodyPr>
                          <a:p>
                            <a:endParaRPr b="0" lang="en-US" sz="2400" spc="-1" strike="noStrike">
                              <a:solidFill>
                                <a:srgbClr val="000000"/>
                              </a:solidFill>
                              <a:latin typeface="Times New Roman"/>
                            </a:endParaRPr>
                          </a:p>
                        </p:txBody>
                      </p:sp>
                      <p:grpSp>
                        <p:nvGrpSpPr>
                          <p:cNvPr id="62" name=""/>
                          <p:cNvGrpSpPr/>
                          <p:nvPr/>
                        </p:nvGrpSpPr>
                        <p:grpSpPr>
                          <a:xfrm>
                            <a:off x="1321920" y="3957840"/>
                            <a:ext cx="1223640" cy="1314000"/>
                            <a:chOff x="1321920" y="3957840"/>
                            <a:chExt cx="1223640" cy="1314000"/>
                          </a:xfrm>
                        </p:grpSpPr>
                        <p:grpSp>
                          <p:nvGrpSpPr>
                            <p:cNvPr id="63" name=""/>
                            <p:cNvGrpSpPr/>
                            <p:nvPr/>
                          </p:nvGrpSpPr>
                          <p:grpSpPr>
                            <a:xfrm>
                              <a:off x="1321920" y="3957840"/>
                              <a:ext cx="1223640" cy="1314000"/>
                              <a:chOff x="1321920" y="3957840"/>
                              <a:chExt cx="1223640" cy="1314000"/>
                            </a:xfrm>
                          </p:grpSpPr>
                          <p:sp>
                            <p:nvSpPr>
                              <p:cNvPr id="64" name=""/>
                              <p:cNvSpPr/>
                              <p:nvPr/>
                            </p:nvSpPr>
                            <p:spPr>
                              <a:xfrm flipV="1" rot="287400">
                                <a:off x="1375920" y="3959280"/>
                                <a:ext cx="95400" cy="1307160"/>
                              </a:xfrm>
                              <a:prstGeom prst="parallelogram">
                                <a:avLst>
                                  <a:gd name="adj" fmla="val 34662"/>
                                </a:avLst>
                              </a:prstGeom>
                              <a:solidFill>
                                <a:srgbClr val="c0c0c0"/>
                              </a:solidFill>
                              <a:ln w="0">
                                <a:noFill/>
                              </a:ln>
                            </p:spPr>
                            <p:style>
                              <a:lnRef idx="0"/>
                              <a:fillRef idx="0"/>
                              <a:effectRef idx="0"/>
                              <a:fontRef idx="minor"/>
                            </p:style>
                            <p:txBody>
                              <a:bodyPr wrap="none" lIns="90000" rIns="90000" tIns="46800" bIns="46800" anchor="ctr">
                                <a:noAutofit/>
                              </a:bodyPr>
                              <a:p>
                                <a:endParaRPr b="0" lang="en-US" sz="2400" spc="-1" strike="noStrike">
                                  <a:solidFill>
                                    <a:srgbClr val="000000"/>
                                  </a:solidFill>
                                  <a:latin typeface="Times New Roman"/>
                                </a:endParaRPr>
                              </a:p>
                            </p:txBody>
                          </p:sp>
                          <p:sp>
                            <p:nvSpPr>
                              <p:cNvPr id="65" name=""/>
                              <p:cNvSpPr/>
                              <p:nvPr/>
                            </p:nvSpPr>
                            <p:spPr>
                              <a:xfrm flipV="1" rot="287400">
                                <a:off x="1594800" y="3959280"/>
                                <a:ext cx="95400" cy="1307160"/>
                              </a:xfrm>
                              <a:prstGeom prst="parallelogram">
                                <a:avLst>
                                  <a:gd name="adj" fmla="val 34662"/>
                                </a:avLst>
                              </a:prstGeom>
                              <a:solidFill>
                                <a:srgbClr val="c0c0c0"/>
                              </a:solidFill>
                              <a:ln w="0">
                                <a:noFill/>
                              </a:ln>
                            </p:spPr>
                            <p:style>
                              <a:lnRef idx="0"/>
                              <a:fillRef idx="0"/>
                              <a:effectRef idx="0"/>
                              <a:fontRef idx="minor"/>
                            </p:style>
                            <p:txBody>
                              <a:bodyPr wrap="none" lIns="90000" rIns="90000" tIns="46800" bIns="46800" anchor="ctr">
                                <a:noAutofit/>
                              </a:bodyPr>
                              <a:p>
                                <a:endParaRPr b="0" lang="en-US" sz="2400" spc="-1" strike="noStrike">
                                  <a:solidFill>
                                    <a:srgbClr val="000000"/>
                                  </a:solidFill>
                                  <a:latin typeface="Times New Roman"/>
                                </a:endParaRPr>
                              </a:p>
                            </p:txBody>
                          </p:sp>
                          <p:grpSp>
                            <p:nvGrpSpPr>
                              <p:cNvPr id="66" name=""/>
                              <p:cNvGrpSpPr/>
                              <p:nvPr/>
                            </p:nvGrpSpPr>
                            <p:grpSpPr>
                              <a:xfrm>
                                <a:off x="1344240" y="3957840"/>
                                <a:ext cx="1201320" cy="1314000"/>
                                <a:chOff x="1344240" y="3957840"/>
                                <a:chExt cx="1201320" cy="1314000"/>
                              </a:xfrm>
                            </p:grpSpPr>
                            <p:sp>
                              <p:nvSpPr>
                                <p:cNvPr id="67" name=""/>
                                <p:cNvSpPr/>
                                <p:nvPr/>
                              </p:nvSpPr>
                              <p:spPr>
                                <a:xfrm flipV="1" rot="287400">
                                  <a:off x="1813680" y="3959280"/>
                                  <a:ext cx="95400" cy="1307160"/>
                                </a:xfrm>
                                <a:prstGeom prst="parallelogram">
                                  <a:avLst>
                                    <a:gd name="adj" fmla="val 34662"/>
                                  </a:avLst>
                                </a:prstGeom>
                                <a:solidFill>
                                  <a:srgbClr val="c0c0c0"/>
                                </a:solidFill>
                                <a:ln w="0">
                                  <a:noFill/>
                                </a:ln>
                              </p:spPr>
                              <p:style>
                                <a:lnRef idx="0"/>
                                <a:fillRef idx="0"/>
                                <a:effectRef idx="0"/>
                                <a:fontRef idx="minor"/>
                              </p:style>
                              <p:txBody>
                                <a:bodyPr wrap="none" lIns="90000" rIns="90000" tIns="46800" bIns="46800" anchor="ctr">
                                  <a:noAutofit/>
                                </a:bodyPr>
                                <a:p>
                                  <a:endParaRPr b="0" lang="en-US" sz="2400" spc="-1" strike="noStrike">
                                    <a:solidFill>
                                      <a:srgbClr val="000000"/>
                                    </a:solidFill>
                                    <a:latin typeface="Times New Roman"/>
                                  </a:endParaRPr>
                                </a:p>
                              </p:txBody>
                            </p:sp>
                            <p:grpSp>
                              <p:nvGrpSpPr>
                                <p:cNvPr id="68" name=""/>
                                <p:cNvGrpSpPr/>
                                <p:nvPr/>
                              </p:nvGrpSpPr>
                              <p:grpSpPr>
                                <a:xfrm>
                                  <a:off x="1344240" y="3957840"/>
                                  <a:ext cx="1201320" cy="1314000"/>
                                  <a:chOff x="1344240" y="3957840"/>
                                  <a:chExt cx="1201320" cy="1314000"/>
                                </a:xfrm>
                              </p:grpSpPr>
                              <p:sp>
                                <p:nvSpPr>
                                  <p:cNvPr id="69" name=""/>
                                  <p:cNvSpPr/>
                                  <p:nvPr/>
                                </p:nvSpPr>
                                <p:spPr>
                                  <a:xfrm flipV="1" rot="287400">
                                    <a:off x="1398240" y="3959280"/>
                                    <a:ext cx="95400" cy="1307160"/>
                                  </a:xfrm>
                                  <a:prstGeom prst="parallelogram">
                                    <a:avLst>
                                      <a:gd name="adj" fmla="val 34662"/>
                                    </a:avLst>
                                  </a:prstGeom>
                                  <a:solidFill>
                                    <a:srgbClr val="c0c0c0"/>
                                  </a:solidFill>
                                  <a:ln w="0">
                                    <a:noFill/>
                                  </a:ln>
                                </p:spPr>
                                <p:style>
                                  <a:lnRef idx="0"/>
                                  <a:fillRef idx="0"/>
                                  <a:effectRef idx="0"/>
                                  <a:fontRef idx="minor"/>
                                </p:style>
                                <p:txBody>
                                  <a:bodyPr wrap="none" lIns="90000" rIns="90000" tIns="46800" bIns="46800" anchor="ctr">
                                    <a:noAutofit/>
                                  </a:bodyPr>
                                  <a:p>
                                    <a:endParaRPr b="0" lang="en-US" sz="2400" spc="-1" strike="noStrike">
                                      <a:solidFill>
                                        <a:srgbClr val="000000"/>
                                      </a:solidFill>
                                      <a:latin typeface="Times New Roman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70" name=""/>
                                  <p:cNvSpPr/>
                                  <p:nvPr/>
                                </p:nvSpPr>
                                <p:spPr>
                                  <a:xfrm flipV="1" rot="287400">
                                    <a:off x="1521720" y="3959280"/>
                                    <a:ext cx="95400" cy="1307160"/>
                                  </a:xfrm>
                                  <a:prstGeom prst="parallelogram">
                                    <a:avLst>
                                      <a:gd name="adj" fmla="val 34662"/>
                                    </a:avLst>
                                  </a:prstGeom>
                                  <a:solidFill>
                                    <a:srgbClr val="c0c0c0"/>
                                  </a:solidFill>
                                  <a:ln w="0">
                                    <a:noFill/>
                                  </a:ln>
                                </p:spPr>
                                <p:style>
                                  <a:lnRef idx="0"/>
                                  <a:fillRef idx="0"/>
                                  <a:effectRef idx="0"/>
                                  <a:fontRef idx="minor"/>
                                </p:style>
                                <p:txBody>
                                  <a:bodyPr wrap="none" lIns="90000" rIns="90000" tIns="46800" bIns="46800" anchor="ctr">
                                    <a:noAutofit/>
                                  </a:bodyPr>
                                  <a:p>
                                    <a:endParaRPr b="0" lang="en-US" sz="2400" spc="-1" strike="noStrike">
                                      <a:solidFill>
                                        <a:srgbClr val="000000"/>
                                      </a:solidFill>
                                      <a:latin typeface="Times New Roman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71" name=""/>
                                  <p:cNvSpPr/>
                                  <p:nvPr/>
                                </p:nvSpPr>
                                <p:spPr>
                                  <a:xfrm flipV="1" rot="287400">
                                    <a:off x="1690200" y="3959280"/>
                                    <a:ext cx="95400" cy="1307160"/>
                                  </a:xfrm>
                                  <a:prstGeom prst="parallelogram">
                                    <a:avLst>
                                      <a:gd name="adj" fmla="val 34662"/>
                                    </a:avLst>
                                  </a:prstGeom>
                                  <a:solidFill>
                                    <a:srgbClr val="c0c0c0"/>
                                  </a:solidFill>
                                  <a:ln w="0">
                                    <a:noFill/>
                                  </a:ln>
                                </p:spPr>
                                <p:style>
                                  <a:lnRef idx="0"/>
                                  <a:fillRef idx="0"/>
                                  <a:effectRef idx="0"/>
                                  <a:fontRef idx="minor"/>
                                </p:style>
                                <p:txBody>
                                  <a:bodyPr wrap="none" lIns="90000" rIns="90000" tIns="46800" bIns="46800" anchor="ctr">
                                    <a:noAutofit/>
                                  </a:bodyPr>
                                  <a:p>
                                    <a:endParaRPr b="0" lang="en-US" sz="2400" spc="-1" strike="noStrike">
                                      <a:solidFill>
                                        <a:srgbClr val="000000"/>
                                      </a:solidFill>
                                      <a:latin typeface="Times New Roman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72" name=""/>
                                  <p:cNvSpPr/>
                                  <p:nvPr/>
                                </p:nvSpPr>
                                <p:spPr>
                                  <a:xfrm flipV="1">
                                    <a:off x="1836720" y="3964320"/>
                                    <a:ext cx="509400" cy="1307160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rgbClr val="c0c0c0"/>
                                  </a:solidFill>
                                  <a:ln w="0">
                                    <a:noFill/>
                                  </a:ln>
                                </p:spPr>
                                <p:style>
                                  <a:lnRef idx="0"/>
                                  <a:fillRef idx="0"/>
                                  <a:effectRef idx="0"/>
                                  <a:fontRef idx="minor"/>
                                </p:style>
                                <p:txBody>
                                  <a:bodyPr wrap="none" lIns="90000" rIns="90000" tIns="46800" bIns="46800" anchor="ctr">
                                    <a:noAutofit/>
                                  </a:bodyPr>
                                  <a:p>
                                    <a:endParaRPr b="0" lang="en-US" sz="2400" spc="-1" strike="noStrike">
                                      <a:solidFill>
                                        <a:srgbClr val="000000"/>
                                      </a:solidFill>
                                      <a:latin typeface="Times New Roman"/>
                                    </a:endParaRPr>
                                  </a:p>
                                </p:txBody>
                              </p:sp>
                              <p:sp>
                                <p:nvSpPr>
                                  <p:cNvPr id="73" name=""/>
                                  <p:cNvSpPr/>
                                  <p:nvPr/>
                                </p:nvSpPr>
                                <p:spPr>
                                  <a:xfrm flipV="1" rot="287400">
                                    <a:off x="2396160" y="3959280"/>
                                    <a:ext cx="95400" cy="1307160"/>
                                  </a:xfrm>
                                  <a:prstGeom prst="parallelogram">
                                    <a:avLst>
                                      <a:gd name="adj" fmla="val 34662"/>
                                    </a:avLst>
                                  </a:prstGeom>
                                  <a:solidFill>
                                    <a:srgbClr val="c0c0c0"/>
                                  </a:solidFill>
                                  <a:ln w="0">
                                    <a:noFill/>
                                  </a:ln>
                                </p:spPr>
                                <p:style>
                                  <a:lnRef idx="0"/>
                                  <a:fillRef idx="0"/>
                                  <a:effectRef idx="0"/>
                                  <a:fontRef idx="minor"/>
                                </p:style>
                                <p:txBody>
                                  <a:bodyPr wrap="none" lIns="90000" rIns="90000" tIns="46800" bIns="46800" anchor="ctr">
                                    <a:noAutofit/>
                                  </a:bodyPr>
                                  <a:p>
                                    <a:endParaRPr b="0" lang="en-US" sz="2400" spc="-1" strike="noStrike">
                                      <a:solidFill>
                                        <a:srgbClr val="000000"/>
                                      </a:solidFill>
                                      <a:latin typeface="Times New Roman"/>
                                    </a:endParaRPr>
                                  </a:p>
                                </p:txBody>
                              </p:sp>
                            </p:grpSp>
                          </p:grpSp>
                        </p:grpSp>
                        <p:grpSp>
                          <p:nvGrpSpPr>
                            <p:cNvPr id="74" name=""/>
                            <p:cNvGrpSpPr/>
                            <p:nvPr/>
                          </p:nvGrpSpPr>
                          <p:grpSpPr>
                            <a:xfrm>
                              <a:off x="1563480" y="3957840"/>
                              <a:ext cx="909360" cy="1310400"/>
                              <a:chOff x="1563480" y="3957840"/>
                              <a:chExt cx="909360" cy="1310400"/>
                            </a:xfrm>
                          </p:grpSpPr>
                          <p:sp>
                            <p:nvSpPr>
                              <p:cNvPr id="75" name=""/>
                              <p:cNvSpPr/>
                              <p:nvPr/>
                            </p:nvSpPr>
                            <p:spPr>
                              <a:xfrm flipV="1" rot="287400">
                                <a:off x="1617480" y="3959280"/>
                                <a:ext cx="95400" cy="1307160"/>
                              </a:xfrm>
                              <a:prstGeom prst="parallelogram">
                                <a:avLst>
                                  <a:gd name="adj" fmla="val 34662"/>
                                </a:avLst>
                              </a:prstGeom>
                              <a:solidFill>
                                <a:srgbClr val="c0c0c0"/>
                              </a:solidFill>
                              <a:ln w="0">
                                <a:noFill/>
                              </a:ln>
                            </p:spPr>
                            <p:style>
                              <a:lnRef idx="0"/>
                              <a:fillRef idx="0"/>
                              <a:effectRef idx="0"/>
                              <a:fontRef idx="minor"/>
                            </p:style>
                            <p:txBody>
                              <a:bodyPr wrap="none" lIns="90000" rIns="90000" tIns="46800" bIns="46800" anchor="ctr">
                                <a:noAutofit/>
                              </a:bodyPr>
                              <a:p>
                                <a:endParaRPr b="0" lang="en-US" sz="2400" spc="-1" strike="noStrike">
                                  <a:solidFill>
                                    <a:srgbClr val="000000"/>
                                  </a:solidFill>
                                  <a:latin typeface="Times New Roman"/>
                                </a:endParaRPr>
                              </a:p>
                            </p:txBody>
                          </p:sp>
                          <p:sp>
                            <p:nvSpPr>
                              <p:cNvPr id="76" name=""/>
                              <p:cNvSpPr/>
                              <p:nvPr/>
                            </p:nvSpPr>
                            <p:spPr>
                              <a:xfrm flipV="1" rot="287400">
                                <a:off x="1763280" y="3959280"/>
                                <a:ext cx="95400" cy="1307160"/>
                              </a:xfrm>
                              <a:prstGeom prst="parallelogram">
                                <a:avLst>
                                  <a:gd name="adj" fmla="val 34662"/>
                                </a:avLst>
                              </a:prstGeom>
                              <a:solidFill>
                                <a:srgbClr val="c0c0c0"/>
                              </a:solidFill>
                              <a:ln w="0">
                                <a:noFill/>
                              </a:ln>
                            </p:spPr>
                            <p:style>
                              <a:lnRef idx="0"/>
                              <a:fillRef idx="0"/>
                              <a:effectRef idx="0"/>
                              <a:fontRef idx="minor"/>
                            </p:style>
                            <p:txBody>
                              <a:bodyPr wrap="none" lIns="90000" rIns="90000" tIns="46800" bIns="46800" anchor="ctr">
                                <a:noAutofit/>
                              </a:bodyPr>
                              <a:p>
                                <a:endParaRPr b="0" lang="en-US" sz="2400" spc="-1" strike="noStrike">
                                  <a:solidFill>
                                    <a:srgbClr val="000000"/>
                                  </a:solidFill>
                                  <a:latin typeface="Times New Roman"/>
                                </a:endParaRPr>
                              </a:p>
                            </p:txBody>
                          </p:sp>
                          <p:sp>
                            <p:nvSpPr>
                              <p:cNvPr id="77" name=""/>
                              <p:cNvSpPr/>
                              <p:nvPr/>
                            </p:nvSpPr>
                            <p:spPr>
                              <a:xfrm flipV="1" rot="287400">
                                <a:off x="2273040" y="3959280"/>
                                <a:ext cx="95400" cy="1307160"/>
                              </a:xfrm>
                              <a:prstGeom prst="parallelogram">
                                <a:avLst>
                                  <a:gd name="adj" fmla="val 34662"/>
                                </a:avLst>
                              </a:prstGeom>
                              <a:solidFill>
                                <a:srgbClr val="c0c0c0"/>
                              </a:solidFill>
                              <a:ln w="0">
                                <a:noFill/>
                              </a:ln>
                            </p:spPr>
                            <p:style>
                              <a:lnRef idx="0"/>
                              <a:fillRef idx="0"/>
                              <a:effectRef idx="0"/>
                              <a:fontRef idx="minor"/>
                            </p:style>
                            <p:txBody>
                              <a:bodyPr wrap="none" lIns="90000" rIns="90000" tIns="46800" bIns="46800" anchor="ctr">
                                <a:noAutofit/>
                              </a:bodyPr>
                              <a:p>
                                <a:endParaRPr b="0" lang="en-US" sz="2400" spc="-1" strike="noStrike">
                                  <a:solidFill>
                                    <a:srgbClr val="000000"/>
                                  </a:solidFill>
                                  <a:latin typeface="Times New Roman"/>
                                </a:endParaRPr>
                              </a:p>
                            </p:txBody>
                          </p:sp>
                          <p:sp>
                            <p:nvSpPr>
                              <p:cNvPr id="78" name=""/>
                              <p:cNvSpPr/>
                              <p:nvPr/>
                            </p:nvSpPr>
                            <p:spPr>
                              <a:xfrm flipV="1" rot="287400">
                                <a:off x="2323440" y="3959280"/>
                                <a:ext cx="95400" cy="1307160"/>
                              </a:xfrm>
                              <a:prstGeom prst="parallelogram">
                                <a:avLst>
                                  <a:gd name="adj" fmla="val 34662"/>
                                </a:avLst>
                              </a:prstGeom>
                              <a:solidFill>
                                <a:srgbClr val="c0c0c0"/>
                              </a:solidFill>
                              <a:ln w="0">
                                <a:noFill/>
                              </a:ln>
                            </p:spPr>
                            <p:style>
                              <a:lnRef idx="0"/>
                              <a:fillRef idx="0"/>
                              <a:effectRef idx="0"/>
                              <a:fontRef idx="minor"/>
                            </p:style>
                            <p:txBody>
                              <a:bodyPr wrap="none" lIns="90000" rIns="90000" tIns="46800" bIns="46800" anchor="ctr">
                                <a:noAutofit/>
                              </a:bodyPr>
                              <a:p>
                                <a:endParaRPr b="0" lang="en-US" sz="2400" spc="-1" strike="noStrike">
                                  <a:solidFill>
                                    <a:srgbClr val="000000"/>
                                  </a:solidFill>
                                  <a:latin typeface="Times New Roman"/>
                                </a:endParaRPr>
                              </a:p>
                            </p:txBody>
                          </p:sp>
                        </p:grpSp>
                      </p:grpSp>
                    </p:grpSp>
                  </p:grpSp>
                </p:grpSp>
              </p:grpSp>
            </p:grpSp>
          </p:grpSp>
        </p:grpSp>
        <p:grpSp>
          <p:nvGrpSpPr>
            <p:cNvPr id="79" name=""/>
            <p:cNvGrpSpPr/>
            <p:nvPr/>
          </p:nvGrpSpPr>
          <p:grpSpPr>
            <a:xfrm>
              <a:off x="2355120" y="3898440"/>
              <a:ext cx="696960" cy="1395720"/>
              <a:chOff x="2355120" y="3898440"/>
              <a:chExt cx="696960" cy="1395720"/>
            </a:xfrm>
          </p:grpSpPr>
          <p:sp>
            <p:nvSpPr>
              <p:cNvPr id="80" name=""/>
              <p:cNvSpPr/>
              <p:nvPr/>
            </p:nvSpPr>
            <p:spPr>
              <a:xfrm rot="10800000">
                <a:off x="2744280" y="3898440"/>
                <a:ext cx="201600" cy="135000"/>
              </a:xfrm>
              <a:prstGeom prst="rtTriangle">
                <a:avLst/>
              </a:prstGeom>
              <a:solidFill>
                <a:srgbClr val="c0c0c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240" bIns="-3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V="1" rot="925800">
                <a:off x="2526840" y="3930120"/>
                <a:ext cx="353160" cy="1340640"/>
              </a:xfrm>
              <a:prstGeom prst="parallelogram">
                <a:avLst>
                  <a:gd name="adj" fmla="val 23222"/>
                </a:avLst>
              </a:prstGeom>
              <a:solidFill>
                <a:srgbClr val="c0c0c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82" name=""/>
            <p:cNvSpPr/>
            <p:nvPr/>
          </p:nvSpPr>
          <p:spPr>
            <a:xfrm flipV="1" rot="20662800">
              <a:off x="5756760" y="3877560"/>
              <a:ext cx="190080" cy="1417680"/>
            </a:xfrm>
            <a:prstGeom prst="parallelogram">
              <a:avLst>
                <a:gd name="adj" fmla="val 68750"/>
              </a:avLst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795280" y="5651640"/>
              <a:ext cx="37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 kb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99840" y="4878360"/>
              <a:ext cx="675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9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~ 15 kb region</a:t>
              </a:r>
              <a:endParaRPr b="0" lang="en-US" sz="9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009800" y="5281560"/>
              <a:ext cx="5379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77800" y="5281560"/>
              <a:ext cx="378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87" name=""/>
            <p:cNvGrpSpPr/>
            <p:nvPr/>
          </p:nvGrpSpPr>
          <p:grpSpPr>
            <a:xfrm>
              <a:off x="595440" y="5167440"/>
              <a:ext cx="296640" cy="230040"/>
              <a:chOff x="595440" y="5167440"/>
              <a:chExt cx="296640" cy="230040"/>
            </a:xfrm>
          </p:grpSpPr>
          <p:sp>
            <p:nvSpPr>
              <p:cNvPr id="88" name=""/>
              <p:cNvSpPr/>
              <p:nvPr/>
            </p:nvSpPr>
            <p:spPr>
              <a:xfrm>
                <a:off x="595440" y="5167440"/>
                <a:ext cx="8244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816120" y="5167440"/>
                <a:ext cx="7596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671400" y="5167440"/>
                <a:ext cx="8424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763560" y="5167440"/>
                <a:ext cx="4932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92" name=""/>
            <p:cNvSpPr/>
            <p:nvPr/>
          </p:nvSpPr>
          <p:spPr>
            <a:xfrm>
              <a:off x="1101600" y="5167440"/>
              <a:ext cx="5400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163520" y="5167440"/>
              <a:ext cx="15552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719440" y="5167440"/>
              <a:ext cx="233280" cy="230040"/>
            </a:xfrm>
            <a:prstGeom prst="rightArrow">
              <a:avLst>
                <a:gd name="adj1" fmla="val 50000"/>
                <a:gd name="adj2" fmla="val 25352"/>
              </a:avLst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0800000">
              <a:off x="4765320" y="5167080"/>
              <a:ext cx="13644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3909960" y="5167440"/>
              <a:ext cx="16992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871800" y="5167440"/>
              <a:ext cx="2088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778200" y="5167440"/>
              <a:ext cx="6840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 rot="10800000">
              <a:off x="4933440" y="5167080"/>
              <a:ext cx="2700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00" name=""/>
            <p:cNvGrpSpPr/>
            <p:nvPr/>
          </p:nvGrpSpPr>
          <p:grpSpPr>
            <a:xfrm>
              <a:off x="4071960" y="5167440"/>
              <a:ext cx="687240" cy="230040"/>
              <a:chOff x="4071960" y="5167440"/>
              <a:chExt cx="687240" cy="230040"/>
            </a:xfrm>
          </p:grpSpPr>
          <p:sp>
            <p:nvSpPr>
              <p:cNvPr id="101" name=""/>
              <p:cNvSpPr/>
              <p:nvPr/>
            </p:nvSpPr>
            <p:spPr>
              <a:xfrm>
                <a:off x="4394160" y="5167440"/>
                <a:ext cx="6984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4460760" y="5167440"/>
                <a:ext cx="257400" cy="230040"/>
              </a:xfrm>
              <a:prstGeom prst="rightArrow">
                <a:avLst>
                  <a:gd name="adj1" fmla="val 50000"/>
                  <a:gd name="adj2" fmla="val 27973"/>
                </a:avLst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4071960" y="5167440"/>
                <a:ext cx="11736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4290840" y="5167440"/>
                <a:ext cx="8892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4214880" y="5167440"/>
                <a:ext cx="6516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4737240" y="5167440"/>
                <a:ext cx="2196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07" name=""/>
            <p:cNvSpPr/>
            <p:nvPr/>
          </p:nvSpPr>
          <p:spPr>
            <a:xfrm>
              <a:off x="6172200" y="5167440"/>
              <a:ext cx="2700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6221520" y="5167440"/>
              <a:ext cx="13176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66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09" name=""/>
            <p:cNvGrpSpPr/>
            <p:nvPr/>
          </p:nvGrpSpPr>
          <p:grpSpPr>
            <a:xfrm>
              <a:off x="1352520" y="5167440"/>
              <a:ext cx="1347840" cy="230040"/>
              <a:chOff x="1352520" y="5167440"/>
              <a:chExt cx="1347840" cy="230040"/>
            </a:xfrm>
          </p:grpSpPr>
          <p:sp>
            <p:nvSpPr>
              <p:cNvPr id="110" name=""/>
              <p:cNvSpPr/>
              <p:nvPr/>
            </p:nvSpPr>
            <p:spPr>
              <a:xfrm>
                <a:off x="1352520" y="5167440"/>
                <a:ext cx="3024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1866960" y="5167440"/>
                <a:ext cx="271440" cy="230040"/>
              </a:xfrm>
              <a:prstGeom prst="rightArrow">
                <a:avLst>
                  <a:gd name="adj1" fmla="val 50000"/>
                  <a:gd name="adj2" fmla="val 29499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1440000" y="5167440"/>
                <a:ext cx="8892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1398600" y="5167440"/>
                <a:ext cx="2232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1539720" y="5167440"/>
                <a:ext cx="2880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1574640" y="5167440"/>
                <a:ext cx="4320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1608120" y="5167440"/>
                <a:ext cx="254160" cy="230040"/>
              </a:xfrm>
              <a:prstGeom prst="rightArrow">
                <a:avLst>
                  <a:gd name="adj1" fmla="val 50000"/>
                  <a:gd name="adj2" fmla="val 27621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166840" y="5167440"/>
                <a:ext cx="16668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344680" y="5167440"/>
                <a:ext cx="8892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440080" y="5167440"/>
                <a:ext cx="17460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602080" y="5167440"/>
                <a:ext cx="9828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21" name=""/>
            <p:cNvSpPr/>
            <p:nvPr/>
          </p:nvSpPr>
          <p:spPr>
            <a:xfrm>
              <a:off x="2968560" y="5167440"/>
              <a:ext cx="781200" cy="230040"/>
            </a:xfrm>
            <a:prstGeom prst="rightArrow">
              <a:avLst>
                <a:gd name="adj1" fmla="val 50000"/>
                <a:gd name="adj2" fmla="val 84898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22" name=""/>
            <p:cNvGrpSpPr/>
            <p:nvPr/>
          </p:nvGrpSpPr>
          <p:grpSpPr>
            <a:xfrm>
              <a:off x="5002200" y="5167440"/>
              <a:ext cx="1052640" cy="484200"/>
              <a:chOff x="5002200" y="5167440"/>
              <a:chExt cx="1052640" cy="484200"/>
            </a:xfrm>
          </p:grpSpPr>
          <p:sp>
            <p:nvSpPr>
              <p:cNvPr id="123" name=""/>
              <p:cNvSpPr/>
              <p:nvPr/>
            </p:nvSpPr>
            <p:spPr>
              <a:xfrm>
                <a:off x="5002200" y="5167440"/>
                <a:ext cx="60480" cy="23040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66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124" name=""/>
              <p:cNvGrpSpPr/>
              <p:nvPr/>
            </p:nvGrpSpPr>
            <p:grpSpPr>
              <a:xfrm>
                <a:off x="5068800" y="5167440"/>
                <a:ext cx="986040" cy="484200"/>
                <a:chOff x="5068800" y="5167440"/>
                <a:chExt cx="986040" cy="484200"/>
              </a:xfrm>
            </p:grpSpPr>
            <p:sp>
              <p:nvSpPr>
                <p:cNvPr id="125" name=""/>
                <p:cNvSpPr/>
                <p:nvPr/>
              </p:nvSpPr>
              <p:spPr>
                <a:xfrm>
                  <a:off x="5925960" y="5651640"/>
                  <a:ext cx="1051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5068800" y="5167440"/>
                  <a:ext cx="60480" cy="2304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66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5151600" y="5167440"/>
                  <a:ext cx="74520" cy="2304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66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5243400" y="5167440"/>
                  <a:ext cx="144720" cy="2304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66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5392800" y="5167440"/>
                  <a:ext cx="182520" cy="2304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66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5541840" y="5167440"/>
                  <a:ext cx="184320" cy="2304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66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5716440" y="5167440"/>
                  <a:ext cx="184320" cy="2304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66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5910120" y="5167440"/>
                  <a:ext cx="144720" cy="2304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66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133" name=""/>
            <p:cNvSpPr/>
            <p:nvPr/>
          </p:nvSpPr>
          <p:spPr>
            <a:xfrm>
              <a:off x="6080040" y="5167440"/>
              <a:ext cx="42840" cy="23004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 flipH="1">
              <a:off x="934560" y="5246640"/>
              <a:ext cx="5076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 flipH="1">
              <a:off x="975960" y="5246640"/>
              <a:ext cx="5076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903240" y="5105520"/>
              <a:ext cx="195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900000" y="5105520"/>
              <a:ext cx="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101600" y="5105520"/>
              <a:ext cx="0" cy="44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1001880" y="5035680"/>
              <a:ext cx="0" cy="69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56120" y="5423040"/>
              <a:ext cx="650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F. magna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7723400">
              <a:off x="4415400" y="3270600"/>
              <a:ext cx="465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erm</a:t>
              </a:r>
              <a:r>
                <a:rPr b="1" lang="it-IT" sz="10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(TR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20560" y="3924360"/>
              <a:ext cx="5727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43" name=""/>
            <p:cNvGrpSpPr/>
            <p:nvPr/>
          </p:nvGrpSpPr>
          <p:grpSpPr>
            <a:xfrm>
              <a:off x="595440" y="3809880"/>
              <a:ext cx="549000" cy="230040"/>
              <a:chOff x="595440" y="3809880"/>
              <a:chExt cx="549000" cy="230040"/>
            </a:xfrm>
          </p:grpSpPr>
          <p:sp>
            <p:nvSpPr>
              <p:cNvPr id="144" name=""/>
              <p:cNvSpPr/>
              <p:nvPr/>
            </p:nvSpPr>
            <p:spPr>
              <a:xfrm>
                <a:off x="595440" y="3809880"/>
                <a:ext cx="8244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816120" y="3809880"/>
                <a:ext cx="7596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671400" y="3809880"/>
                <a:ext cx="8424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895320" y="3809880"/>
                <a:ext cx="19044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1093680" y="3809880"/>
                <a:ext cx="5076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763560" y="3809880"/>
                <a:ext cx="49320" cy="23004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0000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50" name=""/>
            <p:cNvSpPr/>
            <p:nvPr/>
          </p:nvSpPr>
          <p:spPr>
            <a:xfrm>
              <a:off x="1192320" y="3809880"/>
              <a:ext cx="522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271520" y="3809880"/>
              <a:ext cx="428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328760" y="3809880"/>
              <a:ext cx="633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425600" y="3809880"/>
              <a:ext cx="302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940040" y="3809880"/>
              <a:ext cx="271440" cy="230400"/>
            </a:xfrm>
            <a:prstGeom prst="rightArrow">
              <a:avLst>
                <a:gd name="adj1" fmla="val 50000"/>
                <a:gd name="adj2" fmla="val 29453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512720" y="3809880"/>
              <a:ext cx="8892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471680" y="3809880"/>
              <a:ext cx="2232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612800" y="3809880"/>
              <a:ext cx="288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646280" y="3809880"/>
              <a:ext cx="428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681200" y="3809880"/>
              <a:ext cx="253800" cy="230400"/>
            </a:xfrm>
            <a:prstGeom prst="rightArrow">
              <a:avLst>
                <a:gd name="adj1" fmla="val 50000"/>
                <a:gd name="adj2" fmla="val 27539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2211480" y="3809880"/>
              <a:ext cx="252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244600" y="3809880"/>
              <a:ext cx="16668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436840" y="3809880"/>
              <a:ext cx="8892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722680" y="3809880"/>
              <a:ext cx="1746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4827600" y="3809880"/>
              <a:ext cx="414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541600" y="3809880"/>
              <a:ext cx="6048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600280" y="3809880"/>
              <a:ext cx="10332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648240" y="3809880"/>
              <a:ext cx="1616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3881520" y="3809880"/>
              <a:ext cx="1443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 rot="10860600">
              <a:off x="5303160" y="3809520"/>
              <a:ext cx="507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 rot="10800000">
              <a:off x="5213160" y="3809880"/>
              <a:ext cx="3492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 rot="10708800">
              <a:off x="5255640" y="3809520"/>
              <a:ext cx="219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890960" y="3809880"/>
              <a:ext cx="3672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 rot="10800000">
              <a:off x="4978440" y="3809880"/>
              <a:ext cx="1382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57280" y="3809880"/>
              <a:ext cx="237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4325760" y="3809880"/>
              <a:ext cx="18108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4680000" y="3809880"/>
              <a:ext cx="540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4152960" y="3809880"/>
              <a:ext cx="651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046400" y="3809880"/>
              <a:ext cx="669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 rot="10800000">
              <a:off x="4557600" y="3809880"/>
              <a:ext cx="288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592520" y="3809880"/>
              <a:ext cx="7488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 rot="10860600">
              <a:off x="5368680" y="3809520"/>
              <a:ext cx="554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702400" y="3809880"/>
              <a:ext cx="1760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6027840" y="3809880"/>
              <a:ext cx="1569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878440" y="3809880"/>
              <a:ext cx="1764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504040" y="3809880"/>
              <a:ext cx="5688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584680" y="3809880"/>
              <a:ext cx="428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"/>
            <p:cNvSpPr/>
            <p:nvPr/>
          </p:nvSpPr>
          <p:spPr>
            <a:xfrm rot="10860600">
              <a:off x="5434920" y="3809880"/>
              <a:ext cx="4140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5654520" y="3809880"/>
              <a:ext cx="2088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2951280" y="3809880"/>
              <a:ext cx="663480" cy="230400"/>
            </a:xfrm>
            <a:prstGeom prst="rightArrow">
              <a:avLst>
                <a:gd name="adj1" fmla="val 50000"/>
                <a:gd name="adj2" fmla="val 71992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"/>
            <p:cNvSpPr/>
            <p:nvPr/>
          </p:nvSpPr>
          <p:spPr>
            <a:xfrm rot="10800000">
              <a:off x="5143320" y="3809880"/>
              <a:ext cx="4428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884320" y="3809880"/>
              <a:ext cx="9864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92" name=""/>
            <p:cNvGrpSpPr/>
            <p:nvPr/>
          </p:nvGrpSpPr>
          <p:grpSpPr>
            <a:xfrm>
              <a:off x="1193760" y="3678120"/>
              <a:ext cx="201600" cy="68400"/>
              <a:chOff x="1193760" y="3678120"/>
              <a:chExt cx="201600" cy="68400"/>
            </a:xfrm>
          </p:grpSpPr>
          <p:sp>
            <p:nvSpPr>
              <p:cNvPr id="193" name=""/>
              <p:cNvSpPr/>
              <p:nvPr/>
            </p:nvSpPr>
            <p:spPr>
              <a:xfrm>
                <a:off x="1193760" y="3746520"/>
                <a:ext cx="201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292400" y="367812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95" name=""/>
            <p:cNvGrpSpPr/>
            <p:nvPr/>
          </p:nvGrpSpPr>
          <p:grpSpPr>
            <a:xfrm>
              <a:off x="5711760" y="3678120"/>
              <a:ext cx="473040" cy="68400"/>
              <a:chOff x="5711760" y="3678120"/>
              <a:chExt cx="473040" cy="68400"/>
            </a:xfrm>
          </p:grpSpPr>
          <p:sp>
            <p:nvSpPr>
              <p:cNvPr id="196" name=""/>
              <p:cNvSpPr/>
              <p:nvPr/>
            </p:nvSpPr>
            <p:spPr>
              <a:xfrm>
                <a:off x="5711760" y="3746520"/>
                <a:ext cx="473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5943600" y="367812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98" name=""/>
            <p:cNvSpPr/>
            <p:nvPr/>
          </p:nvSpPr>
          <p:spPr>
            <a:xfrm>
              <a:off x="3706920" y="36702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99" name=""/>
            <p:cNvGrpSpPr/>
            <p:nvPr/>
          </p:nvGrpSpPr>
          <p:grpSpPr>
            <a:xfrm>
              <a:off x="2525760" y="3678120"/>
              <a:ext cx="179280" cy="68400"/>
              <a:chOff x="2525760" y="3678120"/>
              <a:chExt cx="179280" cy="68400"/>
            </a:xfrm>
          </p:grpSpPr>
          <p:sp>
            <p:nvSpPr>
              <p:cNvPr id="200" name=""/>
              <p:cNvSpPr/>
              <p:nvPr/>
            </p:nvSpPr>
            <p:spPr>
              <a:xfrm>
                <a:off x="2525760" y="3746520"/>
                <a:ext cx="179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2616120" y="367812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02" name=""/>
            <p:cNvSpPr/>
            <p:nvPr/>
          </p:nvSpPr>
          <p:spPr>
            <a:xfrm>
              <a:off x="4700520" y="36702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990720" y="36702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073480" y="36702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1800360" y="36702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456120" y="4127400"/>
              <a:ext cx="493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n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Times New Roman"/>
                </a:rPr>
                <a:t>18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"/>
            <p:cNvSpPr/>
            <p:nvPr/>
          </p:nvSpPr>
          <p:spPr>
            <a:xfrm rot="17700000">
              <a:off x="653040" y="3082680"/>
              <a:ext cx="1114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TraG/TraD family member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"/>
            <p:cNvSpPr/>
            <p:nvPr/>
          </p:nvSpPr>
          <p:spPr>
            <a:xfrm rot="17700000">
              <a:off x="999000" y="3183840"/>
              <a:ext cx="892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Hypothetical proteins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605480" y="3606840"/>
              <a:ext cx="0" cy="12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"/>
            <p:cNvSpPr/>
            <p:nvPr/>
          </p:nvSpPr>
          <p:spPr>
            <a:xfrm rot="17700000">
              <a:off x="4336200" y="3095280"/>
              <a:ext cx="1089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Spectinomycin transferas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11" name=""/>
            <p:cNvGrpSpPr/>
            <p:nvPr/>
          </p:nvGrpSpPr>
          <p:grpSpPr>
            <a:xfrm>
              <a:off x="4227480" y="3678120"/>
              <a:ext cx="270000" cy="68040"/>
              <a:chOff x="4227480" y="3678120"/>
              <a:chExt cx="270000" cy="68040"/>
            </a:xfrm>
          </p:grpSpPr>
          <p:sp>
            <p:nvSpPr>
              <p:cNvPr id="212" name=""/>
              <p:cNvSpPr/>
              <p:nvPr/>
            </p:nvSpPr>
            <p:spPr>
              <a:xfrm>
                <a:off x="4227480" y="3744720"/>
                <a:ext cx="27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4354560" y="367812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14" name=""/>
            <p:cNvSpPr/>
            <p:nvPr/>
          </p:nvSpPr>
          <p:spPr>
            <a:xfrm rot="17700000">
              <a:off x="4024080" y="3124440"/>
              <a:ext cx="1023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Tetronasin efflux system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"/>
            <p:cNvSpPr/>
            <p:nvPr/>
          </p:nvSpPr>
          <p:spPr>
            <a:xfrm rot="17700000">
              <a:off x="3941280" y="3229200"/>
              <a:ext cx="793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TetR-like regulator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191120" y="36702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 rot="17700000">
              <a:off x="5622120" y="3079440"/>
              <a:ext cx="109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Site specific recombinases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"/>
            <p:cNvSpPr/>
            <p:nvPr/>
          </p:nvSpPr>
          <p:spPr>
            <a:xfrm rot="17700000">
              <a:off x="2340360" y="3183840"/>
              <a:ext cx="892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Hypothetical proteins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"/>
            <p:cNvSpPr/>
            <p:nvPr/>
          </p:nvSpPr>
          <p:spPr>
            <a:xfrm rot="17700000">
              <a:off x="3414960" y="3190320"/>
              <a:ext cx="876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Reverse transcriptas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20" name=""/>
            <p:cNvGrpSpPr/>
            <p:nvPr/>
          </p:nvGrpSpPr>
          <p:grpSpPr>
            <a:xfrm>
              <a:off x="4821120" y="3670200"/>
              <a:ext cx="135000" cy="73080"/>
              <a:chOff x="4821120" y="3670200"/>
              <a:chExt cx="135000" cy="73080"/>
            </a:xfrm>
          </p:grpSpPr>
          <p:sp>
            <p:nvSpPr>
              <p:cNvPr id="221" name=""/>
              <p:cNvSpPr/>
              <p:nvPr/>
            </p:nvSpPr>
            <p:spPr>
              <a:xfrm>
                <a:off x="4821120" y="3743280"/>
                <a:ext cx="135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4889520" y="367020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23" name=""/>
            <p:cNvSpPr/>
            <p:nvPr/>
          </p:nvSpPr>
          <p:spPr>
            <a:xfrm rot="17700000">
              <a:off x="4712760" y="3336840"/>
              <a:ext cx="547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Transposases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 rot="17700000">
              <a:off x="4950000" y="3416040"/>
              <a:ext cx="37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Relaxas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 rot="17700000">
              <a:off x="1496160" y="3068280"/>
              <a:ext cx="109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Type IV secretory protein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235400" y="3809880"/>
              <a:ext cx="90360" cy="23040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0000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27" name=""/>
            <p:cNvGrpSpPr/>
            <p:nvPr/>
          </p:nvGrpSpPr>
          <p:grpSpPr>
            <a:xfrm>
              <a:off x="3962520" y="5035680"/>
              <a:ext cx="761040" cy="80640"/>
              <a:chOff x="3962520" y="5035680"/>
              <a:chExt cx="761040" cy="80640"/>
            </a:xfrm>
          </p:grpSpPr>
          <p:sp>
            <p:nvSpPr>
              <p:cNvPr id="228" name=""/>
              <p:cNvSpPr/>
              <p:nvPr/>
            </p:nvSpPr>
            <p:spPr>
              <a:xfrm>
                <a:off x="3962520" y="5114880"/>
                <a:ext cx="761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4320720" y="5035680"/>
                <a:ext cx="0" cy="80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30" name=""/>
            <p:cNvSpPr/>
            <p:nvPr/>
          </p:nvSpPr>
          <p:spPr>
            <a:xfrm rot="17700000">
              <a:off x="4134240" y="4555080"/>
              <a:ext cx="65592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Multidrug ABC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   </a:t>
              </a: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trasnporters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6172200" y="503244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6248520" y="503244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"/>
            <p:cNvSpPr/>
            <p:nvPr/>
          </p:nvSpPr>
          <p:spPr>
            <a:xfrm rot="17700000">
              <a:off x="6131160" y="4719960"/>
              <a:ext cx="492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Excisionas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 rot="17700000">
              <a:off x="6044400" y="4763880"/>
              <a:ext cx="377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Times New Roman"/>
                </a:rPr>
                <a:t>Integrase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609480" y="6095880"/>
              <a:ext cx="304920" cy="152640"/>
            </a:xfrm>
            <a:prstGeom prst="rect">
              <a:avLst/>
            </a:prstGeom>
            <a:solidFill>
              <a:srgbClr val="c0c0c0">
                <a:alpha val="72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838080" y="6095880"/>
              <a:ext cx="164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Times New Roman"/>
                </a:rPr>
                <a:t>nucleotide identity &gt; 90%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08T13:52:07Z</dcterms:created>
  <dc:creator>Maria_Del Grosso</dc:creator>
  <dc:description/>
  <dc:language>en-US</dc:language>
  <cp:lastModifiedBy>Romina</cp:lastModifiedBy>
  <cp:lastPrinted>2009-01-29T15:10:40Z</cp:lastPrinted>
  <dcterms:modified xsi:type="dcterms:W3CDTF">2010-10-07T15:38:11Z</dcterms:modified>
  <cp:revision>134</cp:revision>
  <dc:subject/>
  <dc:title>PowerPoint Presentation</dc:title>
</cp:coreProperties>
</file>